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119813" cy="5303838"/>
  <p:notesSz cx="9385300" cy="7077075"/>
  <p:defaultTextStyle>
    <a:defPPr>
      <a:defRPr lang="en-US"/>
    </a:defPPr>
    <a:lvl1pPr marL="0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1pPr>
    <a:lvl2pPr marL="364571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2pPr>
    <a:lvl3pPr marL="729143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3pPr>
    <a:lvl4pPr marL="1093714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4pPr>
    <a:lvl5pPr marL="1458285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5pPr>
    <a:lvl6pPr marL="1822856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6pPr>
    <a:lvl7pPr marL="2187428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7pPr>
    <a:lvl8pPr marL="2551999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8pPr>
    <a:lvl9pPr marL="2916570" algn="l" defTabSz="729143" rtl="0" eaLnBrk="1" latinLnBrk="0" hangingPunct="1">
      <a:defRPr sz="143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71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uetzer, Jennifer L" initials="PJL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2362"/>
    <a:srgbClr val="008E40"/>
    <a:srgbClr val="8064A2"/>
    <a:srgbClr val="C00000"/>
    <a:srgbClr val="F79646"/>
    <a:srgbClr val="9EBD5F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78276" autoAdjust="0"/>
  </p:normalViewPr>
  <p:slideViewPr>
    <p:cSldViewPr snapToGrid="0">
      <p:cViewPr varScale="1">
        <p:scale>
          <a:sx n="88" d="100"/>
          <a:sy n="88" d="100"/>
        </p:scale>
        <p:origin x="1116" y="78"/>
      </p:cViewPr>
      <p:guideLst>
        <p:guide orient="horz" pos="1671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068047" cy="355304"/>
          </a:xfrm>
          <a:prstGeom prst="rect">
            <a:avLst/>
          </a:prstGeom>
        </p:spPr>
        <p:txBody>
          <a:bodyPr vert="horz" lIns="93040" tIns="46520" rIns="93040" bIns="465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315090" y="1"/>
            <a:ext cx="4068045" cy="355304"/>
          </a:xfrm>
          <a:prstGeom prst="rect">
            <a:avLst/>
          </a:prstGeom>
        </p:spPr>
        <p:txBody>
          <a:bodyPr vert="horz" lIns="93040" tIns="46520" rIns="93040" bIns="46520" rtlCol="0"/>
          <a:lstStyle>
            <a:lvl1pPr algn="r">
              <a:defRPr sz="1200"/>
            </a:lvl1pPr>
          </a:lstStyle>
          <a:p>
            <a:fld id="{6BEDF778-1BED-49B2-9195-B81150F322C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721771"/>
            <a:ext cx="4068047" cy="355304"/>
          </a:xfrm>
          <a:prstGeom prst="rect">
            <a:avLst/>
          </a:prstGeom>
        </p:spPr>
        <p:txBody>
          <a:bodyPr vert="horz" lIns="93040" tIns="46520" rIns="93040" bIns="465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315090" y="6721771"/>
            <a:ext cx="4068045" cy="355304"/>
          </a:xfrm>
          <a:prstGeom prst="rect">
            <a:avLst/>
          </a:prstGeom>
        </p:spPr>
        <p:txBody>
          <a:bodyPr vert="horz" lIns="93040" tIns="46520" rIns="93040" bIns="46520" rtlCol="0" anchor="b"/>
          <a:lstStyle>
            <a:lvl1pPr algn="r">
              <a:defRPr sz="1200"/>
            </a:lvl1pPr>
          </a:lstStyle>
          <a:p>
            <a:fld id="{71D6FE0C-4E1C-4A24-A269-3DC472AA0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7714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4067384" cy="354332"/>
          </a:xfrm>
          <a:prstGeom prst="rect">
            <a:avLst/>
          </a:prstGeom>
        </p:spPr>
        <p:txBody>
          <a:bodyPr vert="horz" lIns="92156" tIns="46079" rIns="92156" bIns="46079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315811" y="1"/>
            <a:ext cx="4067384" cy="354332"/>
          </a:xfrm>
          <a:prstGeom prst="rect">
            <a:avLst/>
          </a:prstGeom>
        </p:spPr>
        <p:txBody>
          <a:bodyPr vert="horz" lIns="92156" tIns="46079" rIns="92156" bIns="46079" rtlCol="0"/>
          <a:lstStyle>
            <a:lvl1pPr algn="r">
              <a:defRPr sz="1200"/>
            </a:lvl1pPr>
          </a:lstStyle>
          <a:p>
            <a:fld id="{B22C1B0D-7B5F-47BA-953C-B696425C448A}" type="datetimeFigureOut">
              <a:rPr lang="en-GB" smtClean="0"/>
              <a:t>23/10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162300" y="530225"/>
            <a:ext cx="3060700" cy="2654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56" tIns="46079" rIns="92156" bIns="46079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8953" y="3361371"/>
            <a:ext cx="7507398" cy="3185403"/>
          </a:xfrm>
          <a:prstGeom prst="rect">
            <a:avLst/>
          </a:prstGeom>
        </p:spPr>
        <p:txBody>
          <a:bodyPr vert="horz" lIns="92156" tIns="46079" rIns="92156" bIns="4607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6721547"/>
            <a:ext cx="4067384" cy="354332"/>
          </a:xfrm>
          <a:prstGeom prst="rect">
            <a:avLst/>
          </a:prstGeom>
        </p:spPr>
        <p:txBody>
          <a:bodyPr vert="horz" lIns="92156" tIns="46079" rIns="92156" bIns="46079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315811" y="6721547"/>
            <a:ext cx="4067384" cy="354332"/>
          </a:xfrm>
          <a:prstGeom prst="rect">
            <a:avLst/>
          </a:prstGeom>
        </p:spPr>
        <p:txBody>
          <a:bodyPr vert="horz" lIns="92156" tIns="46079" rIns="92156" bIns="46079" rtlCol="0" anchor="b"/>
          <a:lstStyle>
            <a:lvl1pPr algn="r">
              <a:defRPr sz="1200"/>
            </a:lvl1pPr>
          </a:lstStyle>
          <a:p>
            <a:fld id="{957DD6C8-8CEB-44BE-AFF7-48A13F5342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994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1pPr>
    <a:lvl2pPr marL="364571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2pPr>
    <a:lvl3pPr marL="729143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3pPr>
    <a:lvl4pPr marL="1093714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4pPr>
    <a:lvl5pPr marL="1458285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5pPr>
    <a:lvl6pPr marL="1822856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6pPr>
    <a:lvl7pPr marL="2187428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7pPr>
    <a:lvl8pPr marL="2551999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8pPr>
    <a:lvl9pPr marL="2916570" algn="l" defTabSz="729143" rtl="0" eaLnBrk="1" latinLnBrk="0" hangingPunct="1">
      <a:defRPr sz="95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868013"/>
            <a:ext cx="5201841" cy="1846521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785743"/>
            <a:ext cx="4589860" cy="1280533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23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339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82380"/>
            <a:ext cx="1319585" cy="449475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82380"/>
            <a:ext cx="3882256" cy="449475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670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461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322278"/>
            <a:ext cx="5278339" cy="2206249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549399"/>
            <a:ext cx="5278339" cy="1160214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0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411902"/>
            <a:ext cx="2600921" cy="336523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411902"/>
            <a:ext cx="2600921" cy="336523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492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82381"/>
            <a:ext cx="5278339" cy="102516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300177"/>
            <a:ext cx="2588967" cy="6371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937374"/>
            <a:ext cx="2588967" cy="28495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300177"/>
            <a:ext cx="2601718" cy="6371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937374"/>
            <a:ext cx="2601718" cy="28495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584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458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4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53589"/>
            <a:ext cx="1973799" cy="123756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763655"/>
            <a:ext cx="3098155" cy="3769163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591151"/>
            <a:ext cx="1973799" cy="294780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035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53589"/>
            <a:ext cx="1973799" cy="123756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763655"/>
            <a:ext cx="3098155" cy="3769163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591151"/>
            <a:ext cx="1973799" cy="294780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942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82381"/>
            <a:ext cx="5278339" cy="10251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411902"/>
            <a:ext cx="5278339" cy="33652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4915873"/>
            <a:ext cx="1376958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C4467-B6AA-4398-AEE0-BBDE4B880148}" type="datetimeFigureOut">
              <a:rPr lang="en-US" smtClean="0"/>
              <a:t>10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4915873"/>
            <a:ext cx="2065437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4915873"/>
            <a:ext cx="1376958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B5565-91D7-454F-AE41-3A8128F4B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805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microsoft.com/office/2007/relationships/hdphoto" Target="../media/hdphoto1.wdp"/><Relationship Id="rId18" Type="http://schemas.openxmlformats.org/officeDocument/2006/relationships/image" Target="../media/image14.png"/><Relationship Id="rId26" Type="http://schemas.openxmlformats.org/officeDocument/2006/relationships/image" Target="../media/image19.tiff"/><Relationship Id="rId3" Type="http://schemas.openxmlformats.org/officeDocument/2006/relationships/image" Target="../media/image2.jpeg"/><Relationship Id="rId21" Type="http://schemas.microsoft.com/office/2007/relationships/hdphoto" Target="../media/hdphoto5.wdp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17" Type="http://schemas.microsoft.com/office/2007/relationships/hdphoto" Target="../media/hdphoto3.wdp"/><Relationship Id="rId25" Type="http://schemas.openxmlformats.org/officeDocument/2006/relationships/image" Target="../media/image18.tiff"/><Relationship Id="rId2" Type="http://schemas.openxmlformats.org/officeDocument/2006/relationships/image" Target="../media/image1.jpeg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29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17.tiff"/><Relationship Id="rId5" Type="http://schemas.openxmlformats.org/officeDocument/2006/relationships/image" Target="../media/image4.jpeg"/><Relationship Id="rId15" Type="http://schemas.microsoft.com/office/2007/relationships/hdphoto" Target="../media/hdphoto2.wdp"/><Relationship Id="rId23" Type="http://schemas.microsoft.com/office/2007/relationships/hdphoto" Target="../media/hdphoto6.wdp"/><Relationship Id="rId28" Type="http://schemas.openxmlformats.org/officeDocument/2006/relationships/image" Target="../media/image21.tiff"/><Relationship Id="rId10" Type="http://schemas.openxmlformats.org/officeDocument/2006/relationships/image" Target="../media/image9.jpeg"/><Relationship Id="rId19" Type="http://schemas.microsoft.com/office/2007/relationships/hdphoto" Target="../media/hdphoto4.wdp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2.png"/><Relationship Id="rId22" Type="http://schemas.openxmlformats.org/officeDocument/2006/relationships/image" Target="../media/image16.png"/><Relationship Id="rId27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619" y="487134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619" y="1247697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1247697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487134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487134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1247697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6" name="TextBox 35"/>
          <p:cNvSpPr txBox="1"/>
          <p:nvPr/>
        </p:nvSpPr>
        <p:spPr>
          <a:xfrm rot="16200000">
            <a:off x="124109" y="692350"/>
            <a:ext cx="696722" cy="286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I -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28757" y="1457556"/>
            <a:ext cx="696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I +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832516" y="173719"/>
            <a:ext cx="858273" cy="286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 Cart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876378" y="173719"/>
            <a:ext cx="858273" cy="286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niscu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920242" y="173719"/>
            <a:ext cx="858273" cy="286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ndon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964108" y="-1"/>
            <a:ext cx="858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Plate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11026" y="-1"/>
            <a:ext cx="1043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llagen Gel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028" y="1247697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028" y="487134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211870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2876995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47" name="TextBox 46"/>
          <p:cNvSpPr txBox="1"/>
          <p:nvPr/>
        </p:nvSpPr>
        <p:spPr>
          <a:xfrm rot="16200000">
            <a:off x="128757" y="2328566"/>
            <a:ext cx="696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II -</a:t>
            </a:r>
          </a:p>
        </p:txBody>
      </p:sp>
      <p:sp>
        <p:nvSpPr>
          <p:cNvPr id="48" name="TextBox 47"/>
          <p:cNvSpPr txBox="1"/>
          <p:nvPr/>
        </p:nvSpPr>
        <p:spPr>
          <a:xfrm rot="16200000">
            <a:off x="128757" y="3086855"/>
            <a:ext cx="696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II +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128757" y="3965465"/>
            <a:ext cx="696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X -</a:t>
            </a:r>
          </a:p>
        </p:txBody>
      </p:sp>
      <p:cxnSp>
        <p:nvCxnSpPr>
          <p:cNvPr id="61" name="Straight Connector 60"/>
          <p:cNvCxnSpPr/>
          <p:nvPr/>
        </p:nvCxnSpPr>
        <p:spPr>
          <a:xfrm>
            <a:off x="4623106" y="525847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4377630" y="493189"/>
            <a:ext cx="541511" cy="21544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500 </a:t>
            </a:r>
            <a:r>
              <a:rPr lang="el-GR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μ</a:t>
            </a:r>
            <a:r>
              <a:rPr lang="en-US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</a:t>
            </a:r>
            <a:endParaRPr lang="en-US" sz="8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6484" y="451672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3755605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892" y="451672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6484" y="3755605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43" name="TextBox 42"/>
          <p:cNvSpPr txBox="1"/>
          <p:nvPr/>
        </p:nvSpPr>
        <p:spPr>
          <a:xfrm rot="16200000">
            <a:off x="128758" y="4726586"/>
            <a:ext cx="696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 X +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451672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3755605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2876995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755" y="211870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619" y="2876994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619" y="2118706"/>
            <a:ext cx="1013518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1" name="Picture 20"/>
          <p:cNvPicPr>
            <a:picLocks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028" y="2121650"/>
            <a:ext cx="1017496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2" name="Picture 21"/>
          <p:cNvPicPr>
            <a:picLocks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028" y="2875190"/>
            <a:ext cx="1017496" cy="73731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cxnSp>
        <p:nvCxnSpPr>
          <p:cNvPr id="44" name="Straight Connector 43"/>
          <p:cNvCxnSpPr/>
          <p:nvPr/>
        </p:nvCxnSpPr>
        <p:spPr bwMode="auto">
          <a:xfrm>
            <a:off x="1470363" y="525847"/>
            <a:ext cx="19348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251858" y="504596"/>
            <a:ext cx="541511" cy="21544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200 </a:t>
            </a:r>
            <a:r>
              <a:rPr lang="el-GR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μ</a:t>
            </a:r>
            <a:r>
              <a:rPr lang="en-US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</a:t>
            </a:r>
            <a:endParaRPr lang="en-US" sz="800" b="1" dirty="0"/>
          </a:p>
        </p:txBody>
      </p:sp>
      <p:cxnSp>
        <p:nvCxnSpPr>
          <p:cNvPr id="50" name="Straight Connector 49"/>
          <p:cNvCxnSpPr/>
          <p:nvPr/>
        </p:nvCxnSpPr>
        <p:spPr bwMode="auto">
          <a:xfrm>
            <a:off x="1470363" y="1296061"/>
            <a:ext cx="19348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 bwMode="auto">
          <a:xfrm>
            <a:off x="1470363" y="2164129"/>
            <a:ext cx="19348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 bwMode="auto">
          <a:xfrm>
            <a:off x="1470363" y="2924879"/>
            <a:ext cx="19348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2520206" y="525847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274730" y="493189"/>
            <a:ext cx="541511" cy="21544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500 </a:t>
            </a:r>
            <a:r>
              <a:rPr lang="el-GR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μ</a:t>
            </a:r>
            <a:r>
              <a:rPr lang="en-US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</a:t>
            </a:r>
            <a:endParaRPr lang="en-US" sz="800" b="1" dirty="0"/>
          </a:p>
        </p:txBody>
      </p:sp>
      <p:cxnSp>
        <p:nvCxnSpPr>
          <p:cNvPr id="59" name="Straight Connector 58"/>
          <p:cNvCxnSpPr/>
          <p:nvPr/>
        </p:nvCxnSpPr>
        <p:spPr>
          <a:xfrm>
            <a:off x="3586573" y="513710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3341096" y="481052"/>
            <a:ext cx="541511" cy="21544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500 </a:t>
            </a:r>
            <a:r>
              <a:rPr lang="el-GR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μ</a:t>
            </a:r>
            <a:r>
              <a:rPr lang="en-US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</a:t>
            </a:r>
            <a:endParaRPr lang="en-US" sz="800" b="1" dirty="0"/>
          </a:p>
        </p:txBody>
      </p:sp>
      <p:cxnSp>
        <p:nvCxnSpPr>
          <p:cNvPr id="63" name="Straight Connector 62"/>
          <p:cNvCxnSpPr/>
          <p:nvPr/>
        </p:nvCxnSpPr>
        <p:spPr>
          <a:xfrm>
            <a:off x="2520206" y="1296061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3586573" y="1277778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4623106" y="1299590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2520206" y="2174664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3586573" y="2156381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4623106" y="2178193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2520206" y="2918908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3586573" y="2900626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4623106" y="2922438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520206" y="3797520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3586573" y="3779237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5655353" y="3801049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2520206" y="4574292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3586573" y="4556009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5655353" y="4577821"/>
            <a:ext cx="1709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5426541" y="3779237"/>
            <a:ext cx="541511" cy="21544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500 </a:t>
            </a:r>
            <a:r>
              <a:rPr lang="el-GR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μ</a:t>
            </a:r>
            <a:r>
              <a:rPr lang="en-US" sz="8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</a:t>
            </a:r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1994998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07</TotalTime>
  <Words>43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Clare McCorry</dc:creator>
  <cp:lastModifiedBy>Mary Clare McCorry</cp:lastModifiedBy>
  <cp:revision>193</cp:revision>
  <cp:lastPrinted>2015-10-21T17:36:00Z</cp:lastPrinted>
  <dcterms:created xsi:type="dcterms:W3CDTF">2015-04-22T00:58:48Z</dcterms:created>
  <dcterms:modified xsi:type="dcterms:W3CDTF">2015-10-23T18:29:20Z</dcterms:modified>
</cp:coreProperties>
</file>